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B6C2B1-DE5E-49CF-9830-3FCABF8950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CC1DA-A28C-453A-AAF7-EFC0177808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15B35A-044B-46C5-A48A-D35872BDDF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8C55A-9689-44AF-A4CF-7505E14617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1FD89-E729-47F6-89F5-3BD210B6C3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3D52E-11EF-4132-BCF7-C96EB2D2A7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77ED3-8E8A-468A-8F77-3BBF61C42F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024F7-ECCD-4072-BEC1-8A627B6925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F26065-D74A-4455-B426-FE011C7AE5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2A9D6-0CB1-4074-82AC-39BC95F7CE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B92EE-1A73-424F-AE5C-87CEC7B352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B2D79-D8BF-4EA4-8E2F-CD61E8B780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4497AE-B82F-4840-9839-590AE38D13A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9"/>
          <p:cNvGrpSpPr/>
          <p:nvPr/>
        </p:nvGrpSpPr>
        <p:grpSpPr>
          <a:xfrm>
            <a:off x="0" y="50760"/>
            <a:ext cx="9144000" cy="6807240"/>
            <a:chOff x="0" y="50760"/>
            <a:chExt cx="9144000" cy="6807240"/>
          </a:xfrm>
        </p:grpSpPr>
        <p:sp>
          <p:nvSpPr>
            <p:cNvPr id="42" name="Text Box 7"/>
            <p:cNvSpPr/>
            <p:nvPr/>
          </p:nvSpPr>
          <p:spPr>
            <a:xfrm>
              <a:off x="0" y="50760"/>
              <a:ext cx="9144000" cy="10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500" spc="-1" strike="noStrike">
                  <a:solidFill>
                    <a:srgbClr val="000000"/>
                  </a:solidFill>
                  <a:latin typeface="Times New Roman"/>
                </a:rPr>
                <a:t>Supplementary File S5: Histogram analysis</a:t>
              </a:r>
              <a:r>
                <a:rPr b="0" lang="en-US" sz="1500" spc="-1" strike="noStrike">
                  <a:solidFill>
                    <a:srgbClr val="000000"/>
                  </a:solidFill>
                  <a:latin typeface="Times New Roman"/>
                </a:rPr>
                <a:t>. </a:t>
              </a:r>
              <a:r>
                <a:rPr b="1" lang="en-US" sz="1500" spc="-1" strike="noStrike">
                  <a:solidFill>
                    <a:srgbClr val="000000"/>
                  </a:solidFill>
                  <a:latin typeface="Times New Roman"/>
                </a:rPr>
                <a:t>(A) </a:t>
              </a:r>
              <a:r>
                <a:rPr b="0" lang="en-US" sz="1500" spc="-1" strike="noStrike">
                  <a:solidFill>
                    <a:srgbClr val="000000"/>
                  </a:solidFill>
                  <a:latin typeface="Times New Roman"/>
                </a:rPr>
                <a:t>Only Cells; </a:t>
              </a:r>
              <a:r>
                <a:rPr b="1" lang="en-US" sz="1500" spc="-1" strike="noStrike">
                  <a:solidFill>
                    <a:srgbClr val="000000"/>
                  </a:solidFill>
                  <a:latin typeface="Times New Roman"/>
                </a:rPr>
                <a:t>(B) </a:t>
              </a:r>
              <a:r>
                <a:rPr b="0" lang="en-US" sz="1500" spc="-1" strike="noStrike">
                  <a:solidFill>
                    <a:srgbClr val="000000"/>
                  </a:solidFill>
                  <a:latin typeface="Times New Roman"/>
                </a:rPr>
                <a:t>Cells tagged with pre-immune sera; </a:t>
              </a:r>
              <a:r>
                <a:rPr b="1" lang="en-US" sz="1500" spc="-1" strike="noStrike">
                  <a:solidFill>
                    <a:srgbClr val="000000"/>
                  </a:solidFill>
                  <a:latin typeface="Times New Roman"/>
                </a:rPr>
                <a:t>(C) </a:t>
              </a:r>
              <a:r>
                <a:rPr b="0" lang="en-US" sz="1500" spc="-1" strike="noStrike">
                  <a:solidFill>
                    <a:srgbClr val="000000"/>
                  </a:solidFill>
                  <a:latin typeface="Times New Roman"/>
                </a:rPr>
                <a:t>Cells tagged with anti-rFlotP polyclonal sera . (D) Cells tagged with anti-rGapA polyclonal sera. Anti-mouse IgG-FITC was used as secondary antibody. Cells with anti-rFlot antibody showed shift in marker 2 confirming the presence of FlotP on the surface of cell.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14"/>
            <p:cNvGrpSpPr/>
            <p:nvPr/>
          </p:nvGrpSpPr>
          <p:grpSpPr>
            <a:xfrm>
              <a:off x="685800" y="990000"/>
              <a:ext cx="8382240" cy="5868000"/>
              <a:chOff x="685800" y="990000"/>
              <a:chExt cx="8382240" cy="5868000"/>
            </a:xfrm>
          </p:grpSpPr>
          <p:pic>
            <p:nvPicPr>
              <p:cNvPr id="44" name="Picture 2" descr=""/>
              <p:cNvPicPr/>
              <p:nvPr/>
            </p:nvPicPr>
            <p:blipFill>
              <a:blip r:embed="rId1"/>
              <a:srcRect l="0" t="0" r="0" b="3411"/>
              <a:stretch/>
            </p:blipFill>
            <p:spPr>
              <a:xfrm>
                <a:off x="685800" y="990000"/>
                <a:ext cx="3157560" cy="152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4" descr=""/>
              <p:cNvPicPr/>
              <p:nvPr/>
            </p:nvPicPr>
            <p:blipFill>
              <a:blip r:embed="rId2"/>
              <a:srcRect l="0" t="0" r="0" b="5479"/>
              <a:stretch/>
            </p:blipFill>
            <p:spPr>
              <a:xfrm>
                <a:off x="768600" y="3887640"/>
                <a:ext cx="3157560" cy="1448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5" descr=""/>
              <p:cNvPicPr/>
              <p:nvPr/>
            </p:nvPicPr>
            <p:blipFill>
              <a:blip r:embed="rId3"/>
              <a:srcRect l="0" t="0" r="0" b="4518"/>
              <a:stretch/>
            </p:blipFill>
            <p:spPr>
              <a:xfrm>
                <a:off x="768600" y="5325480"/>
                <a:ext cx="3190680" cy="1532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3" descr=""/>
              <p:cNvPicPr/>
              <p:nvPr/>
            </p:nvPicPr>
            <p:blipFill>
              <a:blip r:embed="rId4"/>
              <a:srcRect l="0" t="0" r="0" b="5288"/>
              <a:stretch/>
            </p:blipFill>
            <p:spPr>
              <a:xfrm>
                <a:off x="685800" y="2438640"/>
                <a:ext cx="3157560" cy="152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6" descr=""/>
              <p:cNvPicPr/>
              <p:nvPr/>
            </p:nvPicPr>
            <p:blipFill>
              <a:blip r:embed="rId5"/>
              <a:stretch/>
            </p:blipFill>
            <p:spPr>
              <a:xfrm>
                <a:off x="4092840" y="1062360"/>
                <a:ext cx="4809240" cy="1367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Picture 7" descr=""/>
              <p:cNvPicPr/>
              <p:nvPr/>
            </p:nvPicPr>
            <p:blipFill>
              <a:blip r:embed="rId6"/>
              <a:stretch/>
            </p:blipFill>
            <p:spPr>
              <a:xfrm>
                <a:off x="4175640" y="2511360"/>
                <a:ext cx="4736520" cy="1330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Picture 8" descr=""/>
              <p:cNvPicPr/>
              <p:nvPr/>
            </p:nvPicPr>
            <p:blipFill>
              <a:blip r:embed="rId7"/>
              <a:stretch/>
            </p:blipFill>
            <p:spPr>
              <a:xfrm>
                <a:off x="4258800" y="3887640"/>
                <a:ext cx="4788360" cy="1349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Picture 9" descr=""/>
              <p:cNvPicPr/>
              <p:nvPr/>
            </p:nvPicPr>
            <p:blipFill>
              <a:blip r:embed="rId8"/>
              <a:stretch/>
            </p:blipFill>
            <p:spPr>
              <a:xfrm>
                <a:off x="4341960" y="5409360"/>
                <a:ext cx="4726080" cy="1349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Rectangle 10"/>
              <p:cNvSpPr/>
              <p:nvPr/>
            </p:nvSpPr>
            <p:spPr>
              <a:xfrm>
                <a:off x="685800" y="1134720"/>
                <a:ext cx="8309520" cy="137628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11"/>
              <p:cNvSpPr/>
              <p:nvPr/>
            </p:nvSpPr>
            <p:spPr>
              <a:xfrm>
                <a:off x="685800" y="2511000"/>
                <a:ext cx="8309520" cy="144936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12"/>
              <p:cNvSpPr/>
              <p:nvPr/>
            </p:nvSpPr>
            <p:spPr>
              <a:xfrm>
                <a:off x="685800" y="3960720"/>
                <a:ext cx="8309520" cy="137628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13"/>
              <p:cNvSpPr/>
              <p:nvPr/>
            </p:nvSpPr>
            <p:spPr>
              <a:xfrm>
                <a:off x="685800" y="5337360"/>
                <a:ext cx="8309520" cy="152064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Rectangle 15"/>
            <p:cNvSpPr/>
            <p:nvPr/>
          </p:nvSpPr>
          <p:spPr>
            <a:xfrm>
              <a:off x="232200" y="1142640"/>
              <a:ext cx="497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(A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6"/>
            <p:cNvSpPr/>
            <p:nvPr/>
          </p:nvSpPr>
          <p:spPr>
            <a:xfrm>
              <a:off x="243720" y="246996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(B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7"/>
            <p:cNvSpPr/>
            <p:nvPr/>
          </p:nvSpPr>
          <p:spPr>
            <a:xfrm>
              <a:off x="232200" y="3937680"/>
              <a:ext cx="497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(C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8"/>
            <p:cNvSpPr/>
            <p:nvPr/>
          </p:nvSpPr>
          <p:spPr>
            <a:xfrm>
              <a:off x="244080" y="5285520"/>
              <a:ext cx="497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(D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OMYA</cp:lastModifiedBy>
  <dcterms:modified xsi:type="dcterms:W3CDTF">2015-12-02T20:48:30Z</dcterms:modified>
  <cp:revision>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3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3.PPT</vt:lpwstr>
  </property>
  <property fmtid="{D5CDD505-2E9C-101B-9397-08002B2CF9AE}" pid="6" name="Version">
    <vt:r8>1</vt:r8>
  </property>
</Properties>
</file>